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6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795"/>
  </p:normalViewPr>
  <p:slideViewPr>
    <p:cSldViewPr>
      <p:cViewPr varScale="1">
        <p:scale>
          <a:sx n="120" d="100"/>
          <a:sy n="120" d="100"/>
        </p:scale>
        <p:origin x="1944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/>
              <a:t>Klik om het opmaakprofiel van de modelondertitel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4-07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4-07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4-07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4-07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4-07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4-07-2024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4-07-2024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4-07-2024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4-07-2024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4-07-2024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4-07-2024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36C07-7E76-46D3-B86B-6AF7C60E533E}" type="datetimeFigureOut">
              <a:rPr lang="nl-NL" smtClean="0"/>
              <a:t>24-07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84" y="1975674"/>
            <a:ext cx="4254684" cy="41747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964006"/>
            <a:ext cx="4305142" cy="42242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6F3923FC-912E-D98C-8B7C-A28BD2307C96}"/>
              </a:ext>
            </a:extLst>
          </p:cNvPr>
          <p:cNvGrpSpPr/>
          <p:nvPr/>
        </p:nvGrpSpPr>
        <p:grpSpPr>
          <a:xfrm>
            <a:off x="179512" y="828124"/>
            <a:ext cx="9210875" cy="1232724"/>
            <a:chOff x="-66875" y="248890"/>
            <a:chExt cx="9210875" cy="1232724"/>
          </a:xfrm>
        </p:grpSpPr>
        <p:sp>
          <p:nvSpPr>
            <p:cNvPr id="6" name="TextBox 5"/>
            <p:cNvSpPr txBox="1"/>
            <p:nvPr/>
          </p:nvSpPr>
          <p:spPr>
            <a:xfrm>
              <a:off x="-66875" y="248890"/>
              <a:ext cx="921087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of all toxin fractions analy</a:t>
              </a:r>
              <a:r>
                <a:rPr lang="en-US" altLang="zh-CN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</a:t>
              </a:r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ed for venom</a:t>
              </a:r>
              <a:r>
                <a:rPr lang="zh-CN" alt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nl-NL" altLang="zh-CN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f </a:t>
              </a:r>
              <a:r>
                <a:rPr lang="en-US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B. arietans</a:t>
              </a:r>
              <a:r>
                <a:rPr lang="en-US" altLang="zh-CN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.</a:t>
              </a:r>
              <a:endParaRPr lang="en-US" sz="14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endParaRPr>
            </a:p>
            <a:p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A.</a:t>
              </a:r>
              <a:r>
                <a:rPr lang="en-GB" sz="1400" dirty="0">
                  <a:effectLst/>
                </a:rPr>
                <a:t> 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3x10</a:t>
              </a:r>
              <a:r>
                <a:rPr lang="en-US" altLang="zh-CN" sz="1400" baseline="300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4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B.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oomed-in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ALDI-MS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6800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endParaRPr lang="en-US" sz="1400" dirty="0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4B3CC1F-2B16-CEFC-BFF4-A029895232CE}"/>
                </a:ext>
              </a:extLst>
            </p:cNvPr>
            <p:cNvSpPr txBox="1"/>
            <p:nvPr/>
          </p:nvSpPr>
          <p:spPr>
            <a:xfrm>
              <a:off x="0" y="1112282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A</a:t>
              </a:r>
              <a:endParaRPr lang="en-US" b="1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F3EAEC6-E1E6-AEE3-A2DE-9D3DF639829A}"/>
                </a:ext>
              </a:extLst>
            </p:cNvPr>
            <p:cNvSpPr txBox="1"/>
            <p:nvPr/>
          </p:nvSpPr>
          <p:spPr>
            <a:xfrm>
              <a:off x="4168358" y="1112282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B</a:t>
              </a:r>
              <a:endParaRPr 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935506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250986"/>
            <a:ext cx="4398988" cy="43163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9992" y="2250986"/>
            <a:ext cx="4398988" cy="43163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BC6BC585-3D22-030E-DD7F-DA76745791A1}"/>
              </a:ext>
            </a:extLst>
          </p:cNvPr>
          <p:cNvGrpSpPr/>
          <p:nvPr/>
        </p:nvGrpSpPr>
        <p:grpSpPr>
          <a:xfrm>
            <a:off x="0" y="980728"/>
            <a:ext cx="9210875" cy="1363213"/>
            <a:chOff x="-18858" y="118401"/>
            <a:chExt cx="9210875" cy="1363213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5A3D01D-11DF-7F65-93EE-7537C0E7CC35}"/>
                </a:ext>
              </a:extLst>
            </p:cNvPr>
            <p:cNvSpPr txBox="1"/>
            <p:nvPr/>
          </p:nvSpPr>
          <p:spPr>
            <a:xfrm>
              <a:off x="-18858" y="118401"/>
              <a:ext cx="921087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of all toxin fractions analy</a:t>
              </a:r>
              <a:r>
                <a:rPr lang="en-US" altLang="zh-CN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</a:t>
              </a:r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ed for venom of</a:t>
              </a:r>
              <a:r>
                <a:rPr lang="zh-CN" alt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B. jararaca</a:t>
              </a:r>
              <a:r>
                <a:rPr lang="en-US" altLang="zh-CN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.</a:t>
              </a:r>
              <a:endParaRPr lang="en-US" sz="14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endParaRPr>
            </a:p>
            <a:p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A.</a:t>
              </a:r>
              <a:r>
                <a:rPr lang="en-GB" sz="1400" dirty="0">
                  <a:effectLst/>
                </a:rPr>
                <a:t> 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3x10</a:t>
              </a:r>
              <a:r>
                <a:rPr lang="en-US" altLang="zh-CN" sz="1400" baseline="300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4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B.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oomed-in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ALDI-MS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,000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endParaRPr lang="en-US" sz="1400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1C105CC-AE9A-D43A-5771-365F9A2B10D0}"/>
                </a:ext>
              </a:extLst>
            </p:cNvPr>
            <p:cNvSpPr txBox="1"/>
            <p:nvPr/>
          </p:nvSpPr>
          <p:spPr>
            <a:xfrm>
              <a:off x="0" y="1112282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A</a:t>
              </a:r>
              <a:endParaRPr lang="en-US" b="1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4478DA4-646D-234B-56E6-9A834A381D90}"/>
                </a:ext>
              </a:extLst>
            </p:cNvPr>
            <p:cNvSpPr txBox="1"/>
            <p:nvPr/>
          </p:nvSpPr>
          <p:spPr>
            <a:xfrm>
              <a:off x="4553142" y="1019327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B</a:t>
              </a:r>
              <a:endParaRPr 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6982579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82" y="1806037"/>
            <a:ext cx="4303958" cy="42231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753422"/>
            <a:ext cx="4411200" cy="43283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5BC94A5F-5694-39A2-607C-9C67C945F3BC}"/>
              </a:ext>
            </a:extLst>
          </p:cNvPr>
          <p:cNvGrpSpPr/>
          <p:nvPr/>
        </p:nvGrpSpPr>
        <p:grpSpPr>
          <a:xfrm>
            <a:off x="160800" y="504058"/>
            <a:ext cx="9210875" cy="1363213"/>
            <a:chOff x="-18858" y="118401"/>
            <a:chExt cx="9210875" cy="1363213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C45C7088-2DA4-1C36-DC03-4268B6703F78}"/>
                </a:ext>
              </a:extLst>
            </p:cNvPr>
            <p:cNvSpPr txBox="1"/>
            <p:nvPr/>
          </p:nvSpPr>
          <p:spPr>
            <a:xfrm>
              <a:off x="-18858" y="118401"/>
              <a:ext cx="921087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of all toxin fractions analy</a:t>
              </a:r>
              <a:r>
                <a:rPr lang="en-US" altLang="zh-CN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</a:t>
              </a:r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ed for venom</a:t>
              </a:r>
              <a:r>
                <a:rPr lang="zh-CN" alt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nl-NL" altLang="zh-CN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f </a:t>
              </a:r>
              <a:r>
                <a:rPr lang="en-US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B. asper</a:t>
              </a:r>
              <a:r>
                <a:rPr lang="en-US" altLang="zh-CN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.</a:t>
              </a:r>
              <a:endParaRPr lang="en-US" sz="14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endParaRPr>
            </a:p>
            <a:p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A.</a:t>
              </a:r>
              <a:r>
                <a:rPr lang="en-GB" sz="1400" dirty="0">
                  <a:effectLst/>
                </a:rPr>
                <a:t> 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x10</a:t>
              </a:r>
              <a:r>
                <a:rPr lang="en-US" altLang="zh-CN" sz="1400" baseline="300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B.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oomed-in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ALDI-MS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2,500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endParaRPr lang="en-US" sz="1400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D7444AB-8554-E878-5332-FFF41EE6CF1F}"/>
                </a:ext>
              </a:extLst>
            </p:cNvPr>
            <p:cNvSpPr txBox="1"/>
            <p:nvPr/>
          </p:nvSpPr>
          <p:spPr>
            <a:xfrm>
              <a:off x="0" y="1112282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A</a:t>
              </a:r>
              <a:endParaRPr lang="en-US" b="1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A112284-AF25-D7BB-0584-5D13F3A1E4D0}"/>
                </a:ext>
              </a:extLst>
            </p:cNvPr>
            <p:cNvSpPr txBox="1"/>
            <p:nvPr/>
          </p:nvSpPr>
          <p:spPr>
            <a:xfrm>
              <a:off x="4122857" y="1112282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B</a:t>
              </a:r>
              <a:endParaRPr 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5974731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977258"/>
            <a:ext cx="4454849" cy="43711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1185" y="1950967"/>
            <a:ext cx="4525311" cy="44403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504FB02A-1C79-1F68-BE7B-ABDC2283B47D}"/>
              </a:ext>
            </a:extLst>
          </p:cNvPr>
          <p:cNvGrpSpPr/>
          <p:nvPr/>
        </p:nvGrpSpPr>
        <p:grpSpPr>
          <a:xfrm>
            <a:off x="160800" y="504058"/>
            <a:ext cx="9210875" cy="1363213"/>
            <a:chOff x="-18858" y="118401"/>
            <a:chExt cx="9210875" cy="1363213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A5072C6-7E64-0084-9027-9C2833C74EAB}"/>
                </a:ext>
              </a:extLst>
            </p:cNvPr>
            <p:cNvSpPr txBox="1"/>
            <p:nvPr/>
          </p:nvSpPr>
          <p:spPr>
            <a:xfrm>
              <a:off x="-18858" y="118401"/>
              <a:ext cx="921087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of all toxin fractions analy</a:t>
              </a:r>
              <a:r>
                <a:rPr lang="en-US" altLang="zh-CN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</a:t>
              </a:r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ed for venom</a:t>
              </a:r>
              <a:r>
                <a:rPr lang="zh-CN" alt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nl-NL" altLang="zh-CN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f </a:t>
              </a:r>
              <a:r>
                <a:rPr lang="en-US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C. </a:t>
              </a:r>
              <a:r>
                <a:rPr lang="en-US" sz="1400" b="1" i="1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atrox</a:t>
              </a:r>
              <a:r>
                <a:rPr lang="en-US" altLang="zh-CN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.</a:t>
              </a:r>
              <a:endParaRPr lang="en-US" sz="14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endParaRPr>
            </a:p>
            <a:p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A.</a:t>
              </a:r>
              <a:r>
                <a:rPr lang="en-GB" sz="1400" dirty="0">
                  <a:effectLst/>
                </a:rPr>
                <a:t> 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x10</a:t>
              </a:r>
              <a:r>
                <a:rPr lang="en-US" altLang="zh-CN" sz="1400" baseline="300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B.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oomed-in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ALDI-MS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x10</a:t>
              </a:r>
              <a:r>
                <a:rPr lang="en-US" altLang="zh-CN" sz="1400" baseline="300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4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endParaRPr lang="en-US" sz="1400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516F0C2-6449-7CCD-3171-B24296C32C3F}"/>
                </a:ext>
              </a:extLst>
            </p:cNvPr>
            <p:cNvSpPr txBox="1"/>
            <p:nvPr/>
          </p:nvSpPr>
          <p:spPr>
            <a:xfrm>
              <a:off x="0" y="1112282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A</a:t>
              </a:r>
              <a:endParaRPr lang="en-US" b="1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BC8F9A9-6916-A5B9-3FEB-5FA1E91BB7FC}"/>
                </a:ext>
              </a:extLst>
            </p:cNvPr>
            <p:cNvSpPr txBox="1"/>
            <p:nvPr/>
          </p:nvSpPr>
          <p:spPr>
            <a:xfrm>
              <a:off x="4122857" y="1112282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B</a:t>
              </a:r>
              <a:endParaRPr 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2483030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334975"/>
            <a:ext cx="4499992" cy="32098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937231" y="51798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effectLst/>
              </a:rPr>
              <a:t> </a:t>
            </a:r>
            <a:endParaRPr lang="en-US" dirty="0"/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2376515"/>
            <a:ext cx="4441756" cy="31683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B51F77B2-1F8F-1D41-053F-DE97BD1B5C91}"/>
              </a:ext>
            </a:extLst>
          </p:cNvPr>
          <p:cNvGrpSpPr/>
          <p:nvPr/>
        </p:nvGrpSpPr>
        <p:grpSpPr>
          <a:xfrm>
            <a:off x="160800" y="504058"/>
            <a:ext cx="9210875" cy="1363213"/>
            <a:chOff x="-18858" y="118401"/>
            <a:chExt cx="9210875" cy="1363213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1E66748-B2FA-2969-6664-2BFA621342EF}"/>
                </a:ext>
              </a:extLst>
            </p:cNvPr>
            <p:cNvSpPr txBox="1"/>
            <p:nvPr/>
          </p:nvSpPr>
          <p:spPr>
            <a:xfrm>
              <a:off x="-18858" y="118401"/>
              <a:ext cx="921087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of all toxin fractions analy</a:t>
              </a:r>
              <a:r>
                <a:rPr lang="en-US" altLang="zh-CN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</a:t>
              </a:r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ed for venom of</a:t>
              </a:r>
              <a:r>
                <a:rPr lang="zh-CN" alt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D. </a:t>
              </a:r>
              <a:r>
                <a:rPr lang="en-US" sz="1400" b="1" i="1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russelii</a:t>
              </a:r>
              <a:r>
                <a:rPr lang="en-US" altLang="zh-CN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.</a:t>
              </a:r>
              <a:endParaRPr lang="en-US" sz="14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endParaRPr>
            </a:p>
            <a:p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A.</a:t>
              </a:r>
              <a:r>
                <a:rPr lang="en-GB" sz="1400" dirty="0">
                  <a:effectLst/>
                </a:rPr>
                <a:t> 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2x10</a:t>
              </a:r>
              <a:r>
                <a:rPr lang="en-US" altLang="zh-CN" sz="1400" baseline="300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B.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oomed-in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ALDI-MS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.7x10</a:t>
              </a:r>
              <a:r>
                <a:rPr lang="en-US" altLang="zh-CN" sz="1400" baseline="300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4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endParaRPr lang="en-US" sz="1400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9A6EB60-EC72-B056-D49A-F576022753E3}"/>
                </a:ext>
              </a:extLst>
            </p:cNvPr>
            <p:cNvSpPr txBox="1"/>
            <p:nvPr/>
          </p:nvSpPr>
          <p:spPr>
            <a:xfrm>
              <a:off x="0" y="1112282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A</a:t>
              </a:r>
              <a:endParaRPr lang="en-US" b="1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2105085-90E9-9923-E10D-E8D13F621C0B}"/>
                </a:ext>
              </a:extLst>
            </p:cNvPr>
            <p:cNvSpPr txBox="1"/>
            <p:nvPr/>
          </p:nvSpPr>
          <p:spPr>
            <a:xfrm>
              <a:off x="4122857" y="1112282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B</a:t>
              </a:r>
              <a:endParaRPr 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7807638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1868234"/>
            <a:ext cx="4379310" cy="42970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20" y="1868234"/>
            <a:ext cx="4369154" cy="42871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83B4B766-17BE-FDDF-C9D8-02C145DD1F76}"/>
              </a:ext>
            </a:extLst>
          </p:cNvPr>
          <p:cNvGrpSpPr/>
          <p:nvPr/>
        </p:nvGrpSpPr>
        <p:grpSpPr>
          <a:xfrm>
            <a:off x="160800" y="504058"/>
            <a:ext cx="9210875" cy="1363213"/>
            <a:chOff x="-18858" y="118401"/>
            <a:chExt cx="9210875" cy="1363213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59DAEB2-5BC6-6039-A920-335013A8C19E}"/>
                </a:ext>
              </a:extLst>
            </p:cNvPr>
            <p:cNvSpPr txBox="1"/>
            <p:nvPr/>
          </p:nvSpPr>
          <p:spPr>
            <a:xfrm>
              <a:off x="-18858" y="118401"/>
              <a:ext cx="921087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of all toxin fractions analy</a:t>
              </a:r>
              <a:r>
                <a:rPr lang="en-US" altLang="zh-CN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</a:t>
              </a:r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ed for venom of</a:t>
              </a:r>
              <a:r>
                <a:rPr lang="zh-CN" alt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E. </a:t>
              </a:r>
              <a:r>
                <a:rPr lang="en-US" sz="1400" b="1" i="1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carinatus</a:t>
              </a:r>
              <a:r>
                <a:rPr lang="en-US" altLang="zh-CN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.</a:t>
              </a:r>
              <a:endParaRPr lang="en-US" sz="14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endParaRPr>
            </a:p>
            <a:p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A.</a:t>
              </a:r>
              <a:r>
                <a:rPr lang="en-GB" sz="1400" dirty="0">
                  <a:effectLst/>
                </a:rPr>
                <a:t> 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6x10</a:t>
              </a:r>
              <a:r>
                <a:rPr lang="en-US" altLang="zh-CN" sz="1400" baseline="300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4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B.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oomed-in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ALDI-MS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700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endParaRPr lang="en-US" sz="14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616C964-81ED-FCCE-FAB4-046F69586410}"/>
                </a:ext>
              </a:extLst>
            </p:cNvPr>
            <p:cNvSpPr txBox="1"/>
            <p:nvPr/>
          </p:nvSpPr>
          <p:spPr>
            <a:xfrm>
              <a:off x="0" y="1112282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A</a:t>
              </a:r>
              <a:endParaRPr lang="en-US" b="1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99EE9BC-4331-D1FB-AE67-C9BB146A5B9A}"/>
                </a:ext>
              </a:extLst>
            </p:cNvPr>
            <p:cNvSpPr txBox="1"/>
            <p:nvPr/>
          </p:nvSpPr>
          <p:spPr>
            <a:xfrm>
              <a:off x="4122857" y="1112282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B</a:t>
              </a:r>
              <a:endParaRPr 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5234678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3" y="1831186"/>
            <a:ext cx="4417068" cy="43341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837232" y="494392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effectLst/>
              </a:rPr>
              <a:t> </a:t>
            </a:r>
            <a:endParaRPr lang="en-US" dirty="0"/>
          </a:p>
        </p:txBody>
      </p:sp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0376" y="1831186"/>
            <a:ext cx="4417068" cy="43341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C26C2F10-80EC-3709-2A4E-553CDB0ECF34}"/>
              </a:ext>
            </a:extLst>
          </p:cNvPr>
          <p:cNvGrpSpPr/>
          <p:nvPr/>
        </p:nvGrpSpPr>
        <p:grpSpPr>
          <a:xfrm>
            <a:off x="107504" y="467973"/>
            <a:ext cx="9210875" cy="1363213"/>
            <a:chOff x="-18858" y="118401"/>
            <a:chExt cx="9210875" cy="1363213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58B9F01-8576-7262-4399-E9D3EAC6D028}"/>
                </a:ext>
              </a:extLst>
            </p:cNvPr>
            <p:cNvSpPr txBox="1"/>
            <p:nvPr/>
          </p:nvSpPr>
          <p:spPr>
            <a:xfrm>
              <a:off x="-18858" y="118401"/>
              <a:ext cx="921087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of all toxin fractions analy</a:t>
              </a:r>
              <a:r>
                <a:rPr lang="en-US" altLang="zh-CN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</a:t>
              </a:r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ed for venom</a:t>
              </a:r>
              <a:r>
                <a:rPr lang="zh-CN" alt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nl-NL" altLang="zh-CN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f </a:t>
              </a:r>
              <a:r>
                <a:rPr lang="en-US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E. ocellatus</a:t>
              </a:r>
              <a:r>
                <a:rPr lang="en-US" altLang="zh-CN" sz="1400" b="1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.</a:t>
              </a:r>
              <a:endParaRPr lang="en-US" sz="14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endParaRPr>
            </a:p>
            <a:p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A.</a:t>
              </a:r>
              <a:r>
                <a:rPr lang="en-GB" sz="1400" dirty="0">
                  <a:effectLst/>
                </a:rPr>
                <a:t> 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Superimposed MALDI-MS spectra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4x10</a:t>
              </a:r>
              <a:r>
                <a:rPr lang="en-US" altLang="zh-CN" sz="1400" baseline="300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B.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Zoomed-in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ALDI-MS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overview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400" i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,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,000-55,000;</a:t>
              </a:r>
              <a:r>
                <a:rPr lang="zh-CN" alt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tensity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-</a:t>
              </a:r>
              <a:r>
                <a:rPr lang="zh-CN" alt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6,000</a:t>
              </a:r>
              <a:r>
                <a:rPr lang="en-US" altLang="zh-CN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)</a:t>
              </a:r>
              <a:endParaRPr lang="en-US" sz="1400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3F7FCDC-D09E-BD72-7FE1-BCC096F98BE2}"/>
                </a:ext>
              </a:extLst>
            </p:cNvPr>
            <p:cNvSpPr txBox="1"/>
            <p:nvPr/>
          </p:nvSpPr>
          <p:spPr>
            <a:xfrm>
              <a:off x="0" y="1112282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A</a:t>
              </a:r>
              <a:endParaRPr lang="en-US" b="1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30609A4-66A9-B51A-917A-23C1BF990467}"/>
                </a:ext>
              </a:extLst>
            </p:cNvPr>
            <p:cNvSpPr txBox="1"/>
            <p:nvPr/>
          </p:nvSpPr>
          <p:spPr>
            <a:xfrm>
              <a:off x="4122857" y="1112282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B</a:t>
              </a:r>
              <a:endParaRPr 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995827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2</TotalTime>
  <Words>352</Words>
  <Application>Microsoft Macintosh PowerPoint</Application>
  <PresentationFormat>On-screen Show (4:3)</PresentationFormat>
  <Paragraphs>30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Palatino Linotype</vt:lpstr>
      <vt:lpstr>Office-them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Kool, J. (J)</cp:lastModifiedBy>
  <cp:revision>14</cp:revision>
  <dcterms:created xsi:type="dcterms:W3CDTF">2024-07-17T13:24:07Z</dcterms:created>
  <dcterms:modified xsi:type="dcterms:W3CDTF">2024-07-24T17:47:47Z</dcterms:modified>
</cp:coreProperties>
</file>